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</p:sldIdLst>
  <p:sldSz cy="10058400" cx="77724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3168">
          <p15:clr>
            <a:srgbClr val="747775"/>
          </p15:clr>
        </p15:guide>
        <p15:guide id="2" pos="2448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3168" orient="horz"/>
        <p:guide pos="2448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2104459" y="685800"/>
            <a:ext cx="26496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29f1afcce8b_0_262:notes"/>
          <p:cNvSpPr/>
          <p:nvPr>
            <p:ph idx="2" type="sldImg"/>
          </p:nvPr>
        </p:nvSpPr>
        <p:spPr>
          <a:xfrm>
            <a:off x="2104459" y="685800"/>
            <a:ext cx="26496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29f1afcce8b_0_26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2b80cf4ceda_0_1:notes"/>
          <p:cNvSpPr/>
          <p:nvPr>
            <p:ph idx="2" type="sldImg"/>
          </p:nvPr>
        </p:nvSpPr>
        <p:spPr>
          <a:xfrm>
            <a:off x="2104459" y="685800"/>
            <a:ext cx="26496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2b80cf4ceda_0_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264952" y="1456058"/>
            <a:ext cx="7242600" cy="40140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264945" y="5542289"/>
            <a:ext cx="7242600" cy="155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264945" y="2163089"/>
            <a:ext cx="7242600" cy="3839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264945" y="6164351"/>
            <a:ext cx="7242600" cy="2543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264945" y="4206107"/>
            <a:ext cx="7242600" cy="1646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264945" y="2253729"/>
            <a:ext cx="7242600" cy="66810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264945" y="2253729"/>
            <a:ext cx="3399900" cy="66810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107540" y="2253729"/>
            <a:ext cx="3399900" cy="66810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264945" y="1086507"/>
            <a:ext cx="2386800" cy="14778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264945" y="2717440"/>
            <a:ext cx="2386800" cy="6217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16713" y="880293"/>
            <a:ext cx="5412600" cy="799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886200" y="-244"/>
            <a:ext cx="3886200" cy="100584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25675" y="2411542"/>
            <a:ext cx="3438300" cy="2898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25675" y="5481569"/>
            <a:ext cx="3438300" cy="2415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198575" y="1415969"/>
            <a:ext cx="3261300" cy="7226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264945" y="8273124"/>
            <a:ext cx="5099100" cy="11832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264945" y="870271"/>
            <a:ext cx="7242600" cy="11199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264945" y="2253729"/>
            <a:ext cx="7242600" cy="6681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7201589" y="9119180"/>
            <a:ext cx="466500" cy="7698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4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>
            <p:ph type="ctrTitle"/>
          </p:nvPr>
        </p:nvSpPr>
        <p:spPr>
          <a:xfrm>
            <a:off x="264950" y="3054480"/>
            <a:ext cx="7242600" cy="14250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2200"/>
              <a:t>Design and Testing of A </a:t>
            </a:r>
            <a:r>
              <a:rPr lang="en" sz="2200"/>
              <a:t>Spoke-based Double-lumen Pediatric Gastrostomy Tube</a:t>
            </a:r>
            <a:endParaRPr sz="2200"/>
          </a:p>
        </p:txBody>
      </p:sp>
      <p:sp>
        <p:nvSpPr>
          <p:cNvPr id="55" name="Google Shape;55;p13"/>
          <p:cNvSpPr txBox="1"/>
          <p:nvPr>
            <p:ph idx="1" type="subTitle"/>
          </p:nvPr>
        </p:nvSpPr>
        <p:spPr>
          <a:xfrm>
            <a:off x="264950" y="4551693"/>
            <a:ext cx="7242600" cy="538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1400"/>
              <a:t>Figures</a:t>
            </a:r>
            <a:endParaRPr sz="140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oogle Shape;60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877725" y="1545173"/>
            <a:ext cx="3514829" cy="2267710"/>
          </a:xfrm>
          <a:prstGeom prst="rect">
            <a:avLst/>
          </a:prstGeom>
          <a:noFill/>
          <a:ln>
            <a:noFill/>
          </a:ln>
        </p:spPr>
      </p:pic>
      <p:pic>
        <p:nvPicPr>
          <p:cNvPr id="61" name="Google Shape;61;p14"/>
          <p:cNvPicPr preferRelativeResize="0"/>
          <p:nvPr/>
        </p:nvPicPr>
        <p:blipFill rotWithShape="1">
          <a:blip r:embed="rId4">
            <a:alphaModFix/>
          </a:blip>
          <a:srcRect b="3021" l="10246" r="11889" t="9151"/>
          <a:stretch/>
        </p:blipFill>
        <p:spPr>
          <a:xfrm>
            <a:off x="532250" y="1545175"/>
            <a:ext cx="2973109" cy="2267711"/>
          </a:xfrm>
          <a:prstGeom prst="rect">
            <a:avLst/>
          </a:prstGeom>
          <a:noFill/>
          <a:ln>
            <a:noFill/>
          </a:ln>
        </p:spPr>
      </p:pic>
      <p:pic>
        <p:nvPicPr>
          <p:cNvPr id="62" name="Google Shape;62;p14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532250" y="3965725"/>
            <a:ext cx="3238800" cy="2907792"/>
          </a:xfrm>
          <a:prstGeom prst="rect">
            <a:avLst/>
          </a:prstGeom>
          <a:noFill/>
          <a:ln>
            <a:noFill/>
          </a:ln>
        </p:spPr>
      </p:pic>
      <p:pic>
        <p:nvPicPr>
          <p:cNvPr id="63" name="Google Shape;63;p14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4041108" y="3965738"/>
            <a:ext cx="3188063" cy="2907787"/>
          </a:xfrm>
          <a:prstGeom prst="rect">
            <a:avLst/>
          </a:prstGeom>
          <a:noFill/>
          <a:ln>
            <a:noFill/>
          </a:ln>
        </p:spPr>
      </p:pic>
      <p:sp>
        <p:nvSpPr>
          <p:cNvPr id="64" name="Google Shape;64;p14"/>
          <p:cNvSpPr txBox="1"/>
          <p:nvPr/>
        </p:nvSpPr>
        <p:spPr>
          <a:xfrm>
            <a:off x="514675" y="6980600"/>
            <a:ext cx="6848400" cy="1184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just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/>
              <a:t>Supplementary Figure </a:t>
            </a:r>
            <a:r>
              <a:rPr b="1" lang="en" sz="1100">
                <a:solidFill>
                  <a:srgbClr val="000000"/>
                </a:solidFill>
              </a:rPr>
              <a:t>1. </a:t>
            </a:r>
            <a:r>
              <a:rPr b="1" lang="en" sz="1100"/>
              <a:t>Views of double-lumen G</a:t>
            </a:r>
            <a:r>
              <a:rPr b="1" lang="en" sz="1100">
                <a:solidFill>
                  <a:srgbClr val="000000"/>
                </a:solidFill>
              </a:rPr>
              <a:t>-tube design.</a:t>
            </a:r>
            <a:r>
              <a:rPr lang="en" sz="1100">
                <a:solidFill>
                  <a:srgbClr val="000000"/>
                </a:solidFill>
              </a:rPr>
              <a:t> (A) </a:t>
            </a:r>
            <a:r>
              <a:rPr lang="en" sz="1100"/>
              <a:t>Surface wire frame view (B) Cross-sectional view (C) 3-dimensional view (D) Transparent 3-dimensional view</a:t>
            </a:r>
            <a:endParaRPr sz="1100">
              <a:solidFill>
                <a:srgbClr val="000000"/>
              </a:solidFill>
            </a:endParaRPr>
          </a:p>
        </p:txBody>
      </p:sp>
      <p:sp>
        <p:nvSpPr>
          <p:cNvPr id="65" name="Google Shape;65;p14"/>
          <p:cNvSpPr txBox="1"/>
          <p:nvPr/>
        </p:nvSpPr>
        <p:spPr>
          <a:xfrm>
            <a:off x="514625" y="1527175"/>
            <a:ext cx="4086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>
                <a:solidFill>
                  <a:srgbClr val="000000"/>
                </a:solidFill>
              </a:rPr>
              <a:t>A</a:t>
            </a:r>
            <a:endParaRPr b="1">
              <a:solidFill>
                <a:srgbClr val="000000"/>
              </a:solidFill>
            </a:endParaRPr>
          </a:p>
        </p:txBody>
      </p:sp>
      <p:sp>
        <p:nvSpPr>
          <p:cNvPr id="66" name="Google Shape;66;p14"/>
          <p:cNvSpPr txBox="1"/>
          <p:nvPr/>
        </p:nvSpPr>
        <p:spPr>
          <a:xfrm>
            <a:off x="514625" y="3889375"/>
            <a:ext cx="4086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/>
              <a:t>C</a:t>
            </a:r>
            <a:endParaRPr b="1">
              <a:solidFill>
                <a:srgbClr val="000000"/>
              </a:solidFill>
            </a:endParaRPr>
          </a:p>
        </p:txBody>
      </p:sp>
      <p:sp>
        <p:nvSpPr>
          <p:cNvPr id="67" name="Google Shape;67;p14"/>
          <p:cNvSpPr txBox="1"/>
          <p:nvPr/>
        </p:nvSpPr>
        <p:spPr>
          <a:xfrm>
            <a:off x="4019825" y="3889375"/>
            <a:ext cx="4086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/>
              <a:t>D</a:t>
            </a:r>
            <a:endParaRPr b="1">
              <a:solidFill>
                <a:srgbClr val="000000"/>
              </a:solidFill>
            </a:endParaRPr>
          </a:p>
        </p:txBody>
      </p:sp>
      <p:sp>
        <p:nvSpPr>
          <p:cNvPr id="68" name="Google Shape;68;p14"/>
          <p:cNvSpPr txBox="1"/>
          <p:nvPr/>
        </p:nvSpPr>
        <p:spPr>
          <a:xfrm>
            <a:off x="4019825" y="1527175"/>
            <a:ext cx="408600" cy="4002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"/>
              <a:t>B</a:t>
            </a:r>
            <a:endParaRPr b="1">
              <a:solidFill>
                <a:srgbClr val="0000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